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4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 " initials="" lastIdx="1" clrIdx="0">
    <p:extLst>
      <p:ext uri="{19B8F6BF-5375-455C-9EA6-DF929625EA0E}">
        <p15:presenceInfo xmlns:p15="http://schemas.microsoft.com/office/powerpoint/2012/main" userId="52550388ebc85fb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66"/>
    <a:srgbClr val="0000FF"/>
    <a:srgbClr val="FDF8F5"/>
    <a:srgbClr val="F3F7FB"/>
    <a:srgbClr val="FDF5F1"/>
    <a:srgbClr val="FEFAF8"/>
    <a:srgbClr val="FEF8F4"/>
    <a:srgbClr val="F9FBFD"/>
    <a:srgbClr val="EFF5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60" autoAdjust="0"/>
    <p:restoredTop sz="94660"/>
  </p:normalViewPr>
  <p:slideViewPr>
    <p:cSldViewPr snapToGrid="0">
      <p:cViewPr>
        <p:scale>
          <a:sx n="66" d="100"/>
          <a:sy n="66" d="100"/>
        </p:scale>
        <p:origin x="2304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15C6ED-A65A-40F3-84CB-6B086EA80EE4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AE8DE7-BE11-41CF-9487-6FC593B986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38938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579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57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9632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493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488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3612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979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668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682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567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228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DA098D-C968-4EA0-8734-0DE5CB508A50}" type="datetimeFigureOut">
              <a:rPr kumimoji="1" lang="ja-JP" altLang="en-US" smtClean="0"/>
              <a:t>2022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FA0E7-2804-450E-8F25-0A2BB91526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5908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Rectangle 126">
            <a:extLst>
              <a:ext uri="{FF2B5EF4-FFF2-40B4-BE49-F238E27FC236}">
                <a16:creationId xmlns:a16="http://schemas.microsoft.com/office/drawing/2014/main" id="{B7A6791E-52EF-4E57-B0A0-95F75D7DDD0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49374" y="-693835"/>
            <a:ext cx="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4154" name="テキスト ボックス 4153">
            <a:extLst>
              <a:ext uri="{FF2B5EF4-FFF2-40B4-BE49-F238E27FC236}">
                <a16:creationId xmlns:a16="http://schemas.microsoft.com/office/drawing/2014/main" id="{27F73DEC-B9CE-429A-AE59-88D78499C39E}"/>
              </a:ext>
            </a:extLst>
          </p:cNvPr>
          <p:cNvSpPr txBox="1"/>
          <p:nvPr/>
        </p:nvSpPr>
        <p:spPr>
          <a:xfrm>
            <a:off x="126747" y="132011"/>
            <a:ext cx="6674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The  example images showed remarkably weak H&amp;E staining, which were not detected by the SSD model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ピンク, 飛ぶ, 空気 が含まれている画像&#10;&#10;自動的に生成された説明">
            <a:extLst>
              <a:ext uri="{FF2B5EF4-FFF2-40B4-BE49-F238E27FC236}">
                <a16:creationId xmlns:a16="http://schemas.microsoft.com/office/drawing/2014/main" id="{8E2B7B16-F4E7-CD8B-4195-BEEB24182F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8386" y="813961"/>
            <a:ext cx="3025597" cy="2373018"/>
          </a:xfrm>
          <a:prstGeom prst="rect">
            <a:avLst/>
          </a:prstGeom>
        </p:spPr>
      </p:pic>
      <p:pic>
        <p:nvPicPr>
          <p:cNvPr id="5" name="図 4" descr="ホワイトボードに書かれた絵&#10;&#10;低い精度で自動的に生成された説明">
            <a:extLst>
              <a:ext uri="{FF2B5EF4-FFF2-40B4-BE49-F238E27FC236}">
                <a16:creationId xmlns:a16="http://schemas.microsoft.com/office/drawing/2014/main" id="{92394569-D2EF-6D64-0687-847D2F5EFC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05" y="813961"/>
            <a:ext cx="3025597" cy="2373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2073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85</TotalTime>
  <Words>24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o Yamaguchi</dc:creator>
  <cp:lastModifiedBy>山口　美桜</cp:lastModifiedBy>
  <cp:revision>498</cp:revision>
  <dcterms:created xsi:type="dcterms:W3CDTF">2020-01-27T04:44:46Z</dcterms:created>
  <dcterms:modified xsi:type="dcterms:W3CDTF">2022-06-29T05:44:30Z</dcterms:modified>
</cp:coreProperties>
</file>